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70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  <p:ext uri="{2D200454-40CA-4A62-9FC3-DE9A4176ACB9}">
      <p15:notes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Tomoya Yokota" initials="TY" lastIdx="34" clrIdx="0">
    <p:extLst>
      <p:ext uri="{19B8F6BF-5375-455C-9EA6-DF929625EA0E}">
        <p15:presenceInfo xmlns:p15="http://schemas.microsoft.com/office/powerpoint/2012/main" userId="5b1e16aa1b947b5d" providerId="Windows Live"/>
      </p:ext>
    </p:extLst>
  </p:cmAuthor>
  <p:cmAuthor id="2" name="哲史 鈴木" initials="哲鈴" lastIdx="30" clrIdx="1">
    <p:extLst>
      <p:ext uri="{19B8F6BF-5375-455C-9EA6-DF929625EA0E}">
        <p15:presenceInfo xmlns:p15="http://schemas.microsoft.com/office/powerpoint/2012/main" userId="49451f9d0d17c376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21" autoAdjust="0"/>
    <p:restoredTop sz="90644" autoAdjust="0"/>
  </p:normalViewPr>
  <p:slideViewPr>
    <p:cSldViewPr snapToGrid="0">
      <p:cViewPr varScale="1">
        <p:scale>
          <a:sx n="158" d="100"/>
          <a:sy n="158" d="100"/>
        </p:scale>
        <p:origin x="2586" y="168"/>
      </p:cViewPr>
      <p:guideLst/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notesViewPr>
    <p:cSldViewPr snapToGrid="0">
      <p:cViewPr varScale="1">
        <p:scale>
          <a:sx n="84" d="100"/>
          <a:sy n="84" d="100"/>
        </p:scale>
        <p:origin x="1026" y="90"/>
      </p:cViewPr>
      <p:guideLst/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DDC8FC1-9F99-439D-84B0-91D25A9A2ED3}" type="datetimeFigureOut">
              <a:rPr kumimoji="1" lang="ja-JP" altLang="en-US" smtClean="0"/>
              <a:t>2024/5/15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2C72220-2754-46DA-8604-49F52519CE9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3036754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1200" dirty="0"/>
              <a:t>Figure 1.</a:t>
            </a:r>
            <a:r>
              <a:rPr lang="ja-JP" altLang="en-US" dirty="0"/>
              <a:t> </a:t>
            </a:r>
            <a:r>
              <a:rPr lang="en-US" altLang="ja-JP" sz="1200" dirty="0"/>
              <a:t>SMM and Skeletal Muscle Index (SMI)</a:t>
            </a:r>
            <a:endParaRPr kumimoji="1" lang="en-US" altLang="ja-JP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Delineation of skeletal muscle tissue at the level of C3 using the SYNAPSE VINCENT software program.</a:t>
            </a:r>
            <a:r>
              <a:rPr kumimoji="1" lang="en-US" altLang="ja-JP" sz="1200" dirty="0">
                <a:latin typeface="AdvGulliv-R"/>
                <a:cs typeface="Arial" panose="020B0604020202020204" pitchFamily="34" charset="0"/>
              </a:rPr>
              <a:t> Hounsfield Unit windows </a:t>
            </a:r>
            <a:r>
              <a:rPr lang="en-US" altLang="ja-JP" sz="1200" dirty="0">
                <a:latin typeface="AdvGulliv-R"/>
              </a:rPr>
              <a:t>of -29 to +150 was used to accentuate paravertebral muscle and both sternocleidomastoid muscles.</a:t>
            </a:r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2C72220-2754-46DA-8604-49F52519CE9E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7207794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4C79B65-925B-F23E-6A75-6AE194E4D6B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AB178402-72B7-E0F0-5B8F-E8036F359BB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5D64EDFC-B977-3F5D-4FD0-EB6BAEBE487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8BFE92-FBD8-48DD-B143-B184EEDD29BE}" type="datetimeFigureOut">
              <a:rPr kumimoji="1" lang="ja-JP" altLang="en-US" smtClean="0"/>
              <a:t>2024/5/15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5D5261A5-54E8-C35D-16C5-A981FC68775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667EB47D-16F6-1869-F289-15A0B409DC9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A016B7-F453-47A9-99C8-54B380F428C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237829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740EE72-A9C0-F7AE-337A-0E222527823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EA548C8F-9766-45F4-8C55-5ADA5216AAA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537AE8E0-5217-AF5A-6251-C1CE001FCF7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8BFE92-FBD8-48DD-B143-B184EEDD29BE}" type="datetimeFigureOut">
              <a:rPr kumimoji="1" lang="ja-JP" altLang="en-US" smtClean="0"/>
              <a:t>2024/5/15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08FD43A1-F6A3-F6BE-8A3B-EB866FC142D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34566215-D35C-8661-3CA7-797F93F71F0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A016B7-F453-47A9-99C8-54B380F428C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6915197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C74F174F-F8A8-0245-C426-39A4CAC3AE0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A285B8C7-06F9-3F2E-44B9-915694D7151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41E1A895-0D1B-6034-7A26-00727BF3DA5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8BFE92-FBD8-48DD-B143-B184EEDD29BE}" type="datetimeFigureOut">
              <a:rPr kumimoji="1" lang="ja-JP" altLang="en-US" smtClean="0"/>
              <a:t>2024/5/15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E7CA0ED4-1D68-EEFA-17A2-0EF93793EAF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203ADC74-7F64-3D5A-CE9D-A030F3C5B19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A016B7-F453-47A9-99C8-54B380F428C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4747158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77D089E1-821C-15A1-897B-79E7DD7CF61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91D949EE-1943-695F-C291-7D22CF958C1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1E2C32C3-36BC-4744-648D-7A10FC4EE1B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8BFE92-FBD8-48DD-B143-B184EEDD29BE}" type="datetimeFigureOut">
              <a:rPr kumimoji="1" lang="ja-JP" altLang="en-US" smtClean="0"/>
              <a:t>2024/5/15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7DA0EC1A-FF36-CC03-A21D-22F32BF07FE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5C897E2B-B933-00BB-7600-1C5FEC76D3D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A016B7-F453-47A9-99C8-54B380F428C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4093268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109F321-BFA1-AB7E-0A50-7F62672F33F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851DE096-7C98-08C0-84A6-C0962CB9EE1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B3CB7BDC-6888-7358-9C3F-5C83AD3BF3C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8BFE92-FBD8-48DD-B143-B184EEDD29BE}" type="datetimeFigureOut">
              <a:rPr kumimoji="1" lang="ja-JP" altLang="en-US" smtClean="0"/>
              <a:t>2024/5/15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6127E9DC-2B61-5BB9-2B16-0E1837D887D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989E87C7-0EA6-C009-F59B-6489A3D5100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A016B7-F453-47A9-99C8-54B380F428C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280735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D75F33FE-51DE-7657-EAF7-65810E08918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29F99470-650A-C9CB-402D-8D718B11DA1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89B283A3-2382-C7D5-CBE9-515A65BB99A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4F90B3AA-E784-0F36-118D-AD7B1DF983D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8BFE92-FBD8-48DD-B143-B184EEDD29BE}" type="datetimeFigureOut">
              <a:rPr kumimoji="1" lang="ja-JP" altLang="en-US" smtClean="0"/>
              <a:t>2024/5/15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06A38AFD-87DA-FF09-E601-3D7637E246C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838B1CE1-98AB-59C0-46B8-7B13CA4BBAB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A016B7-F453-47A9-99C8-54B380F428C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0288957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399C872-3C88-C9C4-8760-B2E2C9887D8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C0437298-11D8-4CDA-DBED-4EA3CE1D2F5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42A4A388-CCDC-7ABE-48DE-811CC60D1A7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0028985C-E1E1-D0F0-6332-963F55894C1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F728008F-4A83-1A92-1F4A-BC4135D9367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B8F49A7F-CECF-D51B-E6C5-A724F111423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8BFE92-FBD8-48DD-B143-B184EEDD29BE}" type="datetimeFigureOut">
              <a:rPr kumimoji="1" lang="ja-JP" altLang="en-US" smtClean="0"/>
              <a:t>2024/5/15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ADC95DCA-F396-8DA0-A7F2-B63BFCA185B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FD6AE989-A414-FD72-69B9-B825B01FFB8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A016B7-F453-47A9-99C8-54B380F428C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8145146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9F51102-F2E3-1B0E-0A07-9970545FE09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7E1CB4A2-B4FA-C542-16D2-3208FF91AC7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8BFE92-FBD8-48DD-B143-B184EEDD29BE}" type="datetimeFigureOut">
              <a:rPr kumimoji="1" lang="ja-JP" altLang="en-US" smtClean="0"/>
              <a:t>2024/5/15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54E7C3A3-C106-4EC9-2888-2EC04D7041D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2DDC9D91-417E-46C4-ED0F-859CAE3C466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A016B7-F453-47A9-99C8-54B380F428C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3605486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BFF09D48-1BAB-B217-6C15-858815214AD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8BFE92-FBD8-48DD-B143-B184EEDD29BE}" type="datetimeFigureOut">
              <a:rPr kumimoji="1" lang="ja-JP" altLang="en-US" smtClean="0"/>
              <a:t>2024/5/15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07569434-8141-0A17-9B57-BD88B081B64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C1556FA1-2F7B-2A57-4B68-DB898425212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A016B7-F453-47A9-99C8-54B380F428C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9082464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CD98B20A-FFDA-B6D3-D5D4-3C1B8BC0DA9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F9B46EA0-196B-A10A-D1E1-900E129CD1D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047D17C1-435A-BCBD-B33F-E26415169D2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CCC2C058-A95E-B8B9-D502-20ED0B3FD1D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8BFE92-FBD8-48DD-B143-B184EEDD29BE}" type="datetimeFigureOut">
              <a:rPr kumimoji="1" lang="ja-JP" altLang="en-US" smtClean="0"/>
              <a:t>2024/5/15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7515151F-FEDF-951B-A283-16C7A2D6920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F3BB0F43-8342-A638-1210-FD1D36A47E6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A016B7-F453-47A9-99C8-54B380F428C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507253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63FCE14-76E6-2B3D-C2B5-5307DE5C234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40CEA734-4D5C-06AF-AF21-BF7FEB1F23F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AB3E90C0-1789-D702-9C13-48BF4B47AAA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E7D193E0-BE8C-6C78-27C0-AA3C9387207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8BFE92-FBD8-48DD-B143-B184EEDD29BE}" type="datetimeFigureOut">
              <a:rPr kumimoji="1" lang="ja-JP" altLang="en-US" smtClean="0"/>
              <a:t>2024/5/15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CE195DA8-B06F-9C87-04BC-C992751BE85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555DD82D-F234-14EA-3FE5-D5A92280E4B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A016B7-F453-47A9-99C8-54B380F428C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1826562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13A545F7-7F80-7024-8198-1C412DE64C0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53238B5A-061B-B2EF-BECC-BAEEC91743B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813424C1-A9A7-4055-AF4F-2B8FF13FA88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E8BFE92-FBD8-48DD-B143-B184EEDD29BE}" type="datetimeFigureOut">
              <a:rPr kumimoji="1" lang="ja-JP" altLang="en-US" smtClean="0"/>
              <a:t>2024/5/15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66F766C8-5438-3F4A-CDBB-DDE2CDAD433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BF7CA7EF-FC36-3FC4-B317-C4FC03E2CA1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4A016B7-F453-47A9-99C8-54B380F428C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7984306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B5940B4-D6AB-0F94-49BD-7C23A161A774}"/>
              </a:ext>
            </a:extLst>
          </p:cNvPr>
          <p:cNvSpPr txBox="1">
            <a:spLocks/>
          </p:cNvSpPr>
          <p:nvPr/>
        </p:nvSpPr>
        <p:spPr>
          <a:xfrm>
            <a:off x="60213" y="119314"/>
            <a:ext cx="8785207" cy="585967"/>
          </a:xfrm>
          <a:prstGeom prst="rect">
            <a:avLst/>
          </a:prstGeom>
        </p:spPr>
        <p:txBody>
          <a:bodyPr vert="horz" lIns="91440" tIns="45720" rIns="91440" bIns="45720" rtlCol="0" anchor="b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kumimoji="1"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en-US" altLang="ja-JP" sz="2800" dirty="0">
                <a:latin typeface="Arial" panose="020B0604020202020204" pitchFamily="34" charset="0"/>
                <a:cs typeface="Arial" panose="020B0604020202020204" pitchFamily="34" charset="0"/>
              </a:rPr>
              <a:t>Supplementary figure</a:t>
            </a:r>
          </a:p>
        </p:txBody>
      </p:sp>
      <p:grpSp>
        <p:nvGrpSpPr>
          <p:cNvPr id="15" name="グループ化 14">
            <a:extLst>
              <a:ext uri="{FF2B5EF4-FFF2-40B4-BE49-F238E27FC236}">
                <a16:creationId xmlns:a16="http://schemas.microsoft.com/office/drawing/2014/main" id="{5D506976-3467-0773-54DD-E3B40451203D}"/>
              </a:ext>
            </a:extLst>
          </p:cNvPr>
          <p:cNvGrpSpPr/>
          <p:nvPr/>
        </p:nvGrpSpPr>
        <p:grpSpPr>
          <a:xfrm>
            <a:off x="1124601" y="890457"/>
            <a:ext cx="5559843" cy="5357003"/>
            <a:chOff x="3214658" y="750498"/>
            <a:chExt cx="5559843" cy="5357003"/>
          </a:xfrm>
        </p:grpSpPr>
        <p:graphicFrame>
          <p:nvGraphicFramePr>
            <p:cNvPr id="9" name="オブジェクト 8">
              <a:extLst>
                <a:ext uri="{FF2B5EF4-FFF2-40B4-BE49-F238E27FC236}">
                  <a16:creationId xmlns:a16="http://schemas.microsoft.com/office/drawing/2014/main" id="{DC549AAF-AADE-5EB7-551B-E741D7966699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074003367"/>
                </p:ext>
              </p:extLst>
            </p:nvPr>
          </p:nvGraphicFramePr>
          <p:xfrm>
            <a:off x="3417498" y="750498"/>
            <a:ext cx="5357003" cy="5357003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Acrobat Document" r:id="rId3" imgW="3832825" imgH="3832703" progId="Acrobat.Document.DC">
                    <p:embed/>
                  </p:oleObj>
                </mc:Choice>
                <mc:Fallback>
                  <p:oleObj name="Acrobat Document" r:id="rId3" imgW="3832825" imgH="3832703" progId="Acrobat.Document.DC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4"/>
                        <a:stretch>
                          <a:fillRect/>
                        </a:stretch>
                      </p:blipFill>
                      <p:spPr>
                        <a:xfrm>
                          <a:off x="3417498" y="750498"/>
                          <a:ext cx="5357003" cy="5357003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10" name="テキスト ボックス 9">
              <a:extLst>
                <a:ext uri="{FF2B5EF4-FFF2-40B4-BE49-F238E27FC236}">
                  <a16:creationId xmlns:a16="http://schemas.microsoft.com/office/drawing/2014/main" id="{269C5038-C214-4388-BE58-BEBF90A83580}"/>
                </a:ext>
              </a:extLst>
            </p:cNvPr>
            <p:cNvSpPr txBox="1"/>
            <p:nvPr/>
          </p:nvSpPr>
          <p:spPr>
            <a:xfrm>
              <a:off x="4248538" y="5481345"/>
              <a:ext cx="2292222" cy="461665"/>
            </a:xfrm>
            <a:prstGeom prst="rect">
              <a:avLst/>
            </a:prstGeom>
            <a:solidFill>
              <a:srgbClr val="FFFFFF"/>
            </a:solidFill>
          </p:spPr>
          <p:txBody>
            <a:bodyPr wrap="square" rtlCol="0">
              <a:spAutoFit/>
            </a:bodyPr>
            <a:lstStyle/>
            <a:p>
              <a:r>
                <a:rPr kumimoji="1" lang="en-US" altLang="ja-JP" sz="2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ostoperative</a:t>
              </a:r>
              <a:endParaRPr kumimoji="1" lang="ja-JP" altLang="en-US" sz="2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" name="テキスト ボックス 12">
              <a:extLst>
                <a:ext uri="{FF2B5EF4-FFF2-40B4-BE49-F238E27FC236}">
                  <a16:creationId xmlns:a16="http://schemas.microsoft.com/office/drawing/2014/main" id="{56E7EEB4-1D8B-0D72-1917-96FFE1C6E75A}"/>
                </a:ext>
              </a:extLst>
            </p:cNvPr>
            <p:cNvSpPr txBox="1"/>
            <p:nvPr/>
          </p:nvSpPr>
          <p:spPr>
            <a:xfrm>
              <a:off x="6540760" y="5481344"/>
              <a:ext cx="1455575" cy="461665"/>
            </a:xfrm>
            <a:prstGeom prst="rect">
              <a:avLst/>
            </a:prstGeom>
            <a:solidFill>
              <a:srgbClr val="FFFFFF"/>
            </a:solidFill>
          </p:spPr>
          <p:txBody>
            <a:bodyPr wrap="square" rtlCol="0">
              <a:spAutoFit/>
            </a:bodyPr>
            <a:lstStyle/>
            <a:p>
              <a:r>
                <a:rPr kumimoji="1" lang="en-US" altLang="ja-JP" sz="2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efinitive</a:t>
              </a:r>
              <a:endParaRPr kumimoji="1" lang="ja-JP" altLang="en-US" sz="2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" name="テキスト ボックス 13">
              <a:extLst>
                <a:ext uri="{FF2B5EF4-FFF2-40B4-BE49-F238E27FC236}">
                  <a16:creationId xmlns:a16="http://schemas.microsoft.com/office/drawing/2014/main" id="{680A70AD-E482-17D8-0048-735112BAFF85}"/>
                </a:ext>
              </a:extLst>
            </p:cNvPr>
            <p:cNvSpPr txBox="1"/>
            <p:nvPr/>
          </p:nvSpPr>
          <p:spPr>
            <a:xfrm rot="16200000">
              <a:off x="1649348" y="3020884"/>
              <a:ext cx="3592285" cy="461665"/>
            </a:xfrm>
            <a:prstGeom prst="rect">
              <a:avLst/>
            </a:prstGeom>
            <a:solidFill>
              <a:srgbClr val="FFFFFF"/>
            </a:solidFill>
          </p:spPr>
          <p:txBody>
            <a:bodyPr wrap="square" rtlCol="0">
              <a:spAutoFit/>
            </a:bodyPr>
            <a:lstStyle/>
            <a:p>
              <a:r>
                <a:rPr kumimoji="1" lang="en-US" altLang="ja-JP" sz="2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keletal muscle mass at C3</a:t>
              </a:r>
              <a:endParaRPr kumimoji="1" lang="ja-JP" altLang="en-US" sz="2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9B8F2D3D-CAEC-94A7-F6B0-623BA69D1E98}"/>
              </a:ext>
            </a:extLst>
          </p:cNvPr>
          <p:cNvSpPr txBox="1"/>
          <p:nvPr/>
        </p:nvSpPr>
        <p:spPr>
          <a:xfrm>
            <a:off x="6792687" y="1856792"/>
            <a:ext cx="4488023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Student’s t test</a:t>
            </a:r>
          </a:p>
          <a:p>
            <a:endParaRPr lang="en-US" altLang="ja-JP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Postoperative vs. Definitive </a:t>
            </a:r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= 39.14 vs. 41.39</a:t>
            </a:r>
          </a:p>
          <a:p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=0.0158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4343062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443</TotalTime>
  <Words>74</Words>
  <Application>Microsoft Office PowerPoint</Application>
  <PresentationFormat>ワイド画面</PresentationFormat>
  <Paragraphs>11</Paragraphs>
  <Slides>1</Slides>
  <Notes>1</Notes>
  <HiddenSlides>0</HiddenSlides>
  <MMClips>0</MMClips>
  <ScaleCrop>false</ScaleCrop>
  <HeadingPairs>
    <vt:vector size="8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埋め込まれた OLE サーバー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8" baseType="lpstr">
      <vt:lpstr>AdvGulliv-R</vt:lpstr>
      <vt:lpstr>游ゴシック</vt:lpstr>
      <vt:lpstr>游ゴシック Light</vt:lpstr>
      <vt:lpstr>Arial</vt:lpstr>
      <vt:lpstr>Times New Roman</vt:lpstr>
      <vt:lpstr>Office テーマ</vt:lpstr>
      <vt:lpstr>Acrobat Document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哲史 鈴木</dc:creator>
  <cp:lastModifiedBy>Tomoya Yokota</cp:lastModifiedBy>
  <cp:revision>46</cp:revision>
  <dcterms:created xsi:type="dcterms:W3CDTF">2023-11-17T03:45:50Z</dcterms:created>
  <dcterms:modified xsi:type="dcterms:W3CDTF">2024-05-15T01:11:57Z</dcterms:modified>
</cp:coreProperties>
</file>